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627F4E-9DB1-4740-A863-9A37C295F42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gure 4:  Hazard ratios of joint ER+PR+ and ER-PR- tumors for increased hip circumference across 5-year age-bands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ll models are for a 5 kg/m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increase in BMI and were stratified by age at recruitment and study center. Hazard ratio estimates are shown for all women and HRT never user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lide Number Placehold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9EED9D-4266-4A31-8717-F3F532972FB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30002-E20F-4EF8-BF7F-55B55A0293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85676-CB54-4B04-8F66-2BA10ADA5E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D31CFE-8249-46E5-ACD9-9C25EE8A40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F3414-E8A4-4B17-9419-4A9C3BAA80A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81D3D-3924-4505-A9A3-88611CA023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0D03F8-E043-4181-ADFA-55398248CC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D1CA1-9EED-4AB5-ABFD-96EB83DBED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9D2BD8-8E77-4B77-BDC4-5686DF6431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7076C-3CF1-456B-8452-7701A6B653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E53225-EC44-467A-856C-9DA4CD3E55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3124B9-F525-4CBA-9760-01FC2D5FAB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23B1B-D408-40D9-B0EC-842648BA92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B69FDC-E843-4801-9B90-3717604E12B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5"/>
          <p:cNvSpPr/>
          <p:nvPr/>
        </p:nvSpPr>
        <p:spPr>
          <a:xfrm>
            <a:off x="144360" y="1674720"/>
            <a:ext cx="8926560" cy="33861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2"/>
          <p:cNvSpPr/>
          <p:nvPr/>
        </p:nvSpPr>
        <p:spPr>
          <a:xfrm>
            <a:off x="482760" y="4594320"/>
            <a:ext cx="8447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Figure s4 Hazard ratios of joint ER+PR+ and ER-PR- tumors for increased hip circumference across 5-year age-bands.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ll models are for a 5 kg/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ncrease in BMI and were stratified by age at recruitment and study center. Hazard ratio estimates are shown for all women and HRT never user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Chart 6" descr=""/>
          <p:cNvPicPr/>
          <p:nvPr/>
        </p:nvPicPr>
        <p:blipFill>
          <a:blip r:embed="rId1"/>
          <a:stretch/>
        </p:blipFill>
        <p:spPr>
          <a:xfrm>
            <a:off x="285840" y="1889280"/>
            <a:ext cx="4987800" cy="2755800"/>
          </a:xfrm>
          <a:prstGeom prst="rect">
            <a:avLst/>
          </a:prstGeom>
          <a:ln w="0">
            <a:noFill/>
          </a:ln>
        </p:spPr>
      </p:pic>
      <p:pic>
        <p:nvPicPr>
          <p:cNvPr id="51" name="Chart 9" descr=""/>
          <p:cNvPicPr/>
          <p:nvPr/>
        </p:nvPicPr>
        <p:blipFill>
          <a:blip r:embed="rId2"/>
          <a:stretch/>
        </p:blipFill>
        <p:spPr>
          <a:xfrm>
            <a:off x="3981600" y="1884240"/>
            <a:ext cx="5010120" cy="2766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08T11:43:57Z</dcterms:created>
  <dc:creator>James, Rebecca</dc:creator>
  <dc:description/>
  <dc:language>en-US</dc:language>
  <cp:lastModifiedBy>Rebecca Ritte</cp:lastModifiedBy>
  <cp:lastPrinted>2011-12-13T11:51:43Z</cp:lastPrinted>
  <dcterms:modified xsi:type="dcterms:W3CDTF">2012-05-10T09:12:45Z</dcterms:modified>
  <cp:revision>48</cp:revision>
  <dc:subject/>
  <dc:title>PowerPoint Presentation</dc:title>
</cp:coreProperties>
</file>